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8"/>
  </p:notesMasterIdLst>
  <p:sldIdLst>
    <p:sldId id="281" r:id="rId2"/>
    <p:sldId id="257" r:id="rId3"/>
    <p:sldId id="256" r:id="rId4"/>
    <p:sldId id="258" r:id="rId5"/>
    <p:sldId id="259" r:id="rId6"/>
    <p:sldId id="261" r:id="rId7"/>
    <p:sldId id="260" r:id="rId8"/>
    <p:sldId id="263" r:id="rId9"/>
    <p:sldId id="262" r:id="rId10"/>
    <p:sldId id="276" r:id="rId11"/>
    <p:sldId id="277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8" r:id="rId25"/>
    <p:sldId id="279" r:id="rId26"/>
    <p:sldId id="280" r:id="rId27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4" d="100"/>
          <a:sy n="114" d="100"/>
        </p:scale>
        <p:origin x="-1470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3CB181-02F7-4D59-9D32-0E0229A84FC5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4F4D32-C62B-4476-84A4-9B12B3B3A33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2186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4F4D32-C62B-4476-84A4-9B12B3B3A330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89029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18343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2630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3503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1875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02130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2750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1836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2394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9312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7202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4194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906ABD-DDEB-4C9B-B3A8-4042AD79ACEC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5F398-31AD-4CFA-A467-09A9CA9090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09149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3" Type="http://schemas.openxmlformats.org/officeDocument/2006/relationships/image" Target="../media/image74.png"/><Relationship Id="rId7" Type="http://schemas.openxmlformats.org/officeDocument/2006/relationships/image" Target="../media/image78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7.png"/><Relationship Id="rId5" Type="http://schemas.openxmlformats.org/officeDocument/2006/relationships/image" Target="../media/image76.png"/><Relationship Id="rId10" Type="http://schemas.openxmlformats.org/officeDocument/2006/relationships/image" Target="../media/image81.png"/><Relationship Id="rId4" Type="http://schemas.openxmlformats.org/officeDocument/2006/relationships/image" Target="../media/image75.png"/><Relationship Id="rId9" Type="http://schemas.openxmlformats.org/officeDocument/2006/relationships/image" Target="../media/image80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png"/><Relationship Id="rId3" Type="http://schemas.openxmlformats.org/officeDocument/2006/relationships/image" Target="../media/image83.png"/><Relationship Id="rId7" Type="http://schemas.openxmlformats.org/officeDocument/2006/relationships/image" Target="../media/image87.png"/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6.png"/><Relationship Id="rId5" Type="http://schemas.openxmlformats.org/officeDocument/2006/relationships/image" Target="../media/image85.png"/><Relationship Id="rId10" Type="http://schemas.openxmlformats.org/officeDocument/2006/relationships/image" Target="../media/image90.png"/><Relationship Id="rId4" Type="http://schemas.openxmlformats.org/officeDocument/2006/relationships/image" Target="../media/image84.png"/><Relationship Id="rId9" Type="http://schemas.openxmlformats.org/officeDocument/2006/relationships/image" Target="../media/image89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7.png"/><Relationship Id="rId3" Type="http://schemas.openxmlformats.org/officeDocument/2006/relationships/image" Target="../media/image92.png"/><Relationship Id="rId7" Type="http://schemas.openxmlformats.org/officeDocument/2006/relationships/image" Target="../media/image96.png"/><Relationship Id="rId2" Type="http://schemas.openxmlformats.org/officeDocument/2006/relationships/image" Target="../media/image9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5.png"/><Relationship Id="rId5" Type="http://schemas.openxmlformats.org/officeDocument/2006/relationships/image" Target="../media/image94.png"/><Relationship Id="rId10" Type="http://schemas.openxmlformats.org/officeDocument/2006/relationships/image" Target="../media/image99.png"/><Relationship Id="rId4" Type="http://schemas.openxmlformats.org/officeDocument/2006/relationships/image" Target="../media/image93.png"/><Relationship Id="rId9" Type="http://schemas.openxmlformats.org/officeDocument/2006/relationships/image" Target="../media/image98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6.png"/><Relationship Id="rId3" Type="http://schemas.openxmlformats.org/officeDocument/2006/relationships/image" Target="../media/image101.png"/><Relationship Id="rId7" Type="http://schemas.openxmlformats.org/officeDocument/2006/relationships/image" Target="../media/image105.png"/><Relationship Id="rId2" Type="http://schemas.openxmlformats.org/officeDocument/2006/relationships/image" Target="../media/image10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4.png"/><Relationship Id="rId5" Type="http://schemas.openxmlformats.org/officeDocument/2006/relationships/image" Target="../media/image103.png"/><Relationship Id="rId10" Type="http://schemas.openxmlformats.org/officeDocument/2006/relationships/image" Target="../media/image108.png"/><Relationship Id="rId4" Type="http://schemas.openxmlformats.org/officeDocument/2006/relationships/image" Target="../media/image102.png"/><Relationship Id="rId9" Type="http://schemas.openxmlformats.org/officeDocument/2006/relationships/image" Target="../media/image107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5.png"/><Relationship Id="rId3" Type="http://schemas.openxmlformats.org/officeDocument/2006/relationships/image" Target="../media/image110.png"/><Relationship Id="rId7" Type="http://schemas.openxmlformats.org/officeDocument/2006/relationships/image" Target="../media/image114.png"/><Relationship Id="rId2" Type="http://schemas.openxmlformats.org/officeDocument/2006/relationships/image" Target="../media/image10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3.png"/><Relationship Id="rId5" Type="http://schemas.openxmlformats.org/officeDocument/2006/relationships/image" Target="../media/image112.png"/><Relationship Id="rId10" Type="http://schemas.openxmlformats.org/officeDocument/2006/relationships/image" Target="../media/image117.png"/><Relationship Id="rId4" Type="http://schemas.openxmlformats.org/officeDocument/2006/relationships/image" Target="../media/image111.png"/><Relationship Id="rId9" Type="http://schemas.openxmlformats.org/officeDocument/2006/relationships/image" Target="../media/image116.pn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4.png"/><Relationship Id="rId3" Type="http://schemas.openxmlformats.org/officeDocument/2006/relationships/image" Target="../media/image119.png"/><Relationship Id="rId7" Type="http://schemas.openxmlformats.org/officeDocument/2006/relationships/image" Target="../media/image123.png"/><Relationship Id="rId2" Type="http://schemas.openxmlformats.org/officeDocument/2006/relationships/image" Target="../media/image1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2.png"/><Relationship Id="rId5" Type="http://schemas.openxmlformats.org/officeDocument/2006/relationships/image" Target="../media/image121.png"/><Relationship Id="rId10" Type="http://schemas.openxmlformats.org/officeDocument/2006/relationships/image" Target="../media/image126.png"/><Relationship Id="rId4" Type="http://schemas.openxmlformats.org/officeDocument/2006/relationships/image" Target="../media/image120.png"/><Relationship Id="rId9" Type="http://schemas.openxmlformats.org/officeDocument/2006/relationships/image" Target="../media/image125.pn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3.png"/><Relationship Id="rId3" Type="http://schemas.openxmlformats.org/officeDocument/2006/relationships/image" Target="../media/image128.png"/><Relationship Id="rId7" Type="http://schemas.openxmlformats.org/officeDocument/2006/relationships/image" Target="../media/image132.png"/><Relationship Id="rId2" Type="http://schemas.openxmlformats.org/officeDocument/2006/relationships/image" Target="../media/image1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1.png"/><Relationship Id="rId5" Type="http://schemas.openxmlformats.org/officeDocument/2006/relationships/image" Target="../media/image130.png"/><Relationship Id="rId10" Type="http://schemas.openxmlformats.org/officeDocument/2006/relationships/image" Target="../media/image135.png"/><Relationship Id="rId4" Type="http://schemas.openxmlformats.org/officeDocument/2006/relationships/image" Target="../media/image129.png"/><Relationship Id="rId9" Type="http://schemas.openxmlformats.org/officeDocument/2006/relationships/image" Target="../media/image134.pn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2.png"/><Relationship Id="rId3" Type="http://schemas.openxmlformats.org/officeDocument/2006/relationships/image" Target="../media/image137.png"/><Relationship Id="rId7" Type="http://schemas.openxmlformats.org/officeDocument/2006/relationships/image" Target="../media/image141.png"/><Relationship Id="rId2" Type="http://schemas.openxmlformats.org/officeDocument/2006/relationships/image" Target="../media/image13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0.png"/><Relationship Id="rId5" Type="http://schemas.openxmlformats.org/officeDocument/2006/relationships/image" Target="../media/image139.png"/><Relationship Id="rId10" Type="http://schemas.openxmlformats.org/officeDocument/2006/relationships/image" Target="../media/image144.png"/><Relationship Id="rId4" Type="http://schemas.openxmlformats.org/officeDocument/2006/relationships/image" Target="../media/image138.png"/><Relationship Id="rId9" Type="http://schemas.openxmlformats.org/officeDocument/2006/relationships/image" Target="../media/image143.pn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1.png"/><Relationship Id="rId3" Type="http://schemas.openxmlformats.org/officeDocument/2006/relationships/image" Target="../media/image146.png"/><Relationship Id="rId7" Type="http://schemas.openxmlformats.org/officeDocument/2006/relationships/image" Target="../media/image150.png"/><Relationship Id="rId2" Type="http://schemas.openxmlformats.org/officeDocument/2006/relationships/image" Target="../media/image14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9.png"/><Relationship Id="rId5" Type="http://schemas.openxmlformats.org/officeDocument/2006/relationships/image" Target="../media/image148.png"/><Relationship Id="rId10" Type="http://schemas.openxmlformats.org/officeDocument/2006/relationships/image" Target="../media/image153.png"/><Relationship Id="rId4" Type="http://schemas.openxmlformats.org/officeDocument/2006/relationships/image" Target="../media/image147.png"/><Relationship Id="rId9" Type="http://schemas.openxmlformats.org/officeDocument/2006/relationships/image" Target="../media/image152.pn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1.png"/><Relationship Id="rId3" Type="http://schemas.openxmlformats.org/officeDocument/2006/relationships/image" Target="../media/image146.png"/><Relationship Id="rId7" Type="http://schemas.openxmlformats.org/officeDocument/2006/relationships/image" Target="../media/image150.png"/><Relationship Id="rId2" Type="http://schemas.openxmlformats.org/officeDocument/2006/relationships/image" Target="../media/image14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9.png"/><Relationship Id="rId5" Type="http://schemas.openxmlformats.org/officeDocument/2006/relationships/image" Target="../media/image148.png"/><Relationship Id="rId10" Type="http://schemas.openxmlformats.org/officeDocument/2006/relationships/image" Target="../media/image153.png"/><Relationship Id="rId4" Type="http://schemas.openxmlformats.org/officeDocument/2006/relationships/image" Target="../media/image147.png"/><Relationship Id="rId9" Type="http://schemas.openxmlformats.org/officeDocument/2006/relationships/image" Target="../media/image15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0.png"/><Relationship Id="rId3" Type="http://schemas.openxmlformats.org/officeDocument/2006/relationships/image" Target="../media/image155.png"/><Relationship Id="rId7" Type="http://schemas.openxmlformats.org/officeDocument/2006/relationships/image" Target="../media/image159.png"/><Relationship Id="rId2" Type="http://schemas.openxmlformats.org/officeDocument/2006/relationships/image" Target="../media/image15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8.png"/><Relationship Id="rId5" Type="http://schemas.openxmlformats.org/officeDocument/2006/relationships/image" Target="../media/image157.png"/><Relationship Id="rId10" Type="http://schemas.openxmlformats.org/officeDocument/2006/relationships/image" Target="../media/image162.png"/><Relationship Id="rId4" Type="http://schemas.openxmlformats.org/officeDocument/2006/relationships/image" Target="../media/image156.png"/><Relationship Id="rId9" Type="http://schemas.openxmlformats.org/officeDocument/2006/relationships/image" Target="../media/image161.png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9.png"/><Relationship Id="rId3" Type="http://schemas.openxmlformats.org/officeDocument/2006/relationships/image" Target="../media/image164.png"/><Relationship Id="rId7" Type="http://schemas.openxmlformats.org/officeDocument/2006/relationships/image" Target="../media/image168.png"/><Relationship Id="rId2" Type="http://schemas.openxmlformats.org/officeDocument/2006/relationships/image" Target="../media/image16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7.png"/><Relationship Id="rId5" Type="http://schemas.openxmlformats.org/officeDocument/2006/relationships/image" Target="../media/image166.png"/><Relationship Id="rId10" Type="http://schemas.openxmlformats.org/officeDocument/2006/relationships/image" Target="../media/image171.png"/><Relationship Id="rId4" Type="http://schemas.openxmlformats.org/officeDocument/2006/relationships/image" Target="../media/image165.png"/><Relationship Id="rId9" Type="http://schemas.openxmlformats.org/officeDocument/2006/relationships/image" Target="../media/image170.png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8.png"/><Relationship Id="rId3" Type="http://schemas.openxmlformats.org/officeDocument/2006/relationships/image" Target="../media/image173.png"/><Relationship Id="rId7" Type="http://schemas.openxmlformats.org/officeDocument/2006/relationships/image" Target="../media/image177.png"/><Relationship Id="rId2" Type="http://schemas.openxmlformats.org/officeDocument/2006/relationships/image" Target="../media/image17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6.png"/><Relationship Id="rId5" Type="http://schemas.openxmlformats.org/officeDocument/2006/relationships/image" Target="../media/image175.png"/><Relationship Id="rId10" Type="http://schemas.openxmlformats.org/officeDocument/2006/relationships/image" Target="../media/image180.png"/><Relationship Id="rId4" Type="http://schemas.openxmlformats.org/officeDocument/2006/relationships/image" Target="../media/image174.png"/><Relationship Id="rId9" Type="http://schemas.openxmlformats.org/officeDocument/2006/relationships/image" Target="../media/image179.png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7.png"/><Relationship Id="rId3" Type="http://schemas.openxmlformats.org/officeDocument/2006/relationships/image" Target="../media/image182.png"/><Relationship Id="rId7" Type="http://schemas.openxmlformats.org/officeDocument/2006/relationships/image" Target="../media/image186.png"/><Relationship Id="rId2" Type="http://schemas.openxmlformats.org/officeDocument/2006/relationships/image" Target="../media/image18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5.png"/><Relationship Id="rId5" Type="http://schemas.openxmlformats.org/officeDocument/2006/relationships/image" Target="../media/image184.png"/><Relationship Id="rId10" Type="http://schemas.openxmlformats.org/officeDocument/2006/relationships/image" Target="../media/image189.png"/><Relationship Id="rId4" Type="http://schemas.openxmlformats.org/officeDocument/2006/relationships/image" Target="../media/image183.png"/><Relationship Id="rId9" Type="http://schemas.openxmlformats.org/officeDocument/2006/relationships/image" Target="../media/image188.png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6.png"/><Relationship Id="rId3" Type="http://schemas.openxmlformats.org/officeDocument/2006/relationships/image" Target="../media/image191.png"/><Relationship Id="rId7" Type="http://schemas.openxmlformats.org/officeDocument/2006/relationships/image" Target="../media/image195.png"/><Relationship Id="rId2" Type="http://schemas.openxmlformats.org/officeDocument/2006/relationships/image" Target="../media/image19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4.png"/><Relationship Id="rId5" Type="http://schemas.openxmlformats.org/officeDocument/2006/relationships/image" Target="../media/image193.png"/><Relationship Id="rId10" Type="http://schemas.openxmlformats.org/officeDocument/2006/relationships/image" Target="../media/image198.png"/><Relationship Id="rId4" Type="http://schemas.openxmlformats.org/officeDocument/2006/relationships/image" Target="../media/image192.png"/><Relationship Id="rId9" Type="http://schemas.openxmlformats.org/officeDocument/2006/relationships/image" Target="../media/image197.png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5.png"/><Relationship Id="rId3" Type="http://schemas.openxmlformats.org/officeDocument/2006/relationships/image" Target="../media/image200.png"/><Relationship Id="rId7" Type="http://schemas.openxmlformats.org/officeDocument/2006/relationships/image" Target="../media/image204.png"/><Relationship Id="rId2" Type="http://schemas.openxmlformats.org/officeDocument/2006/relationships/image" Target="../media/image19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3.png"/><Relationship Id="rId5" Type="http://schemas.openxmlformats.org/officeDocument/2006/relationships/image" Target="../media/image202.png"/><Relationship Id="rId10" Type="http://schemas.openxmlformats.org/officeDocument/2006/relationships/image" Target="../media/image207.png"/><Relationship Id="rId4" Type="http://schemas.openxmlformats.org/officeDocument/2006/relationships/image" Target="../media/image201.png"/><Relationship Id="rId9" Type="http://schemas.openxmlformats.org/officeDocument/2006/relationships/image" Target="../media/image206.png"/></Relationships>
</file>

<file path=ppt/slides/_rels/slide2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4.png"/><Relationship Id="rId3" Type="http://schemas.openxmlformats.org/officeDocument/2006/relationships/image" Target="../media/image209.png"/><Relationship Id="rId7" Type="http://schemas.openxmlformats.org/officeDocument/2006/relationships/image" Target="../media/image213.png"/><Relationship Id="rId2" Type="http://schemas.openxmlformats.org/officeDocument/2006/relationships/image" Target="../media/image20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2.png"/><Relationship Id="rId5" Type="http://schemas.openxmlformats.org/officeDocument/2006/relationships/image" Target="../media/image211.png"/><Relationship Id="rId10" Type="http://schemas.openxmlformats.org/officeDocument/2006/relationships/image" Target="../media/image216.png"/><Relationship Id="rId4" Type="http://schemas.openxmlformats.org/officeDocument/2006/relationships/image" Target="../media/image210.png"/><Relationship Id="rId9" Type="http://schemas.openxmlformats.org/officeDocument/2006/relationships/image" Target="../media/image21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0" Type="http://schemas.openxmlformats.org/officeDocument/2006/relationships/image" Target="../media/image26.png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10" Type="http://schemas.openxmlformats.org/officeDocument/2006/relationships/image" Target="../media/image36.png"/><Relationship Id="rId4" Type="http://schemas.openxmlformats.org/officeDocument/2006/relationships/image" Target="../media/image30.png"/><Relationship Id="rId9" Type="http://schemas.openxmlformats.org/officeDocument/2006/relationships/image" Target="../media/image3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3" Type="http://schemas.openxmlformats.org/officeDocument/2006/relationships/image" Target="../media/image47.png"/><Relationship Id="rId7" Type="http://schemas.openxmlformats.org/officeDocument/2006/relationships/image" Target="../media/image51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0.png"/><Relationship Id="rId5" Type="http://schemas.openxmlformats.org/officeDocument/2006/relationships/image" Target="../media/image49.png"/><Relationship Id="rId10" Type="http://schemas.openxmlformats.org/officeDocument/2006/relationships/image" Target="../media/image54.png"/><Relationship Id="rId4" Type="http://schemas.openxmlformats.org/officeDocument/2006/relationships/image" Target="../media/image48.png"/><Relationship Id="rId9" Type="http://schemas.openxmlformats.org/officeDocument/2006/relationships/image" Target="../media/image53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png"/><Relationship Id="rId5" Type="http://schemas.openxmlformats.org/officeDocument/2006/relationships/image" Target="../media/image58.png"/><Relationship Id="rId10" Type="http://schemas.openxmlformats.org/officeDocument/2006/relationships/image" Target="../media/image63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png"/><Relationship Id="rId3" Type="http://schemas.openxmlformats.org/officeDocument/2006/relationships/image" Target="../media/image65.png"/><Relationship Id="rId7" Type="http://schemas.openxmlformats.org/officeDocument/2006/relationships/image" Target="../media/image69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8.png"/><Relationship Id="rId5" Type="http://schemas.openxmlformats.org/officeDocument/2006/relationships/image" Target="../media/image67.png"/><Relationship Id="rId10" Type="http://schemas.openxmlformats.org/officeDocument/2006/relationships/image" Target="../media/image72.png"/><Relationship Id="rId4" Type="http://schemas.openxmlformats.org/officeDocument/2006/relationships/image" Target="../media/image66.png"/><Relationship Id="rId9" Type="http://schemas.openxmlformats.org/officeDocument/2006/relationships/image" Target="../media/image7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 algn="just">
              <a:buNone/>
            </a:pPr>
            <a:r>
              <a:rPr lang="es-E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5. </a:t>
            </a:r>
            <a:r>
              <a:rPr lang="es-E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s</a:t>
            </a:r>
            <a:r>
              <a:rPr lang="es-E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ample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ide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rol,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rrhosi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HCC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w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(.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ff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and .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an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ing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S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ported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o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kyline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form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per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how light precursor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dogenou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ide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Medium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nel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heavy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ide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ak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lection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alization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tom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nel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how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lapping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light (red) and heavy (blue) </a:t>
            </a:r>
            <a:r>
              <a:rPr lang="es-E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ides</a:t>
            </a:r>
            <a:r>
              <a:rPr lang="es-E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s-E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501336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INLVLS</a:t>
            </a:r>
            <a:r>
              <a:rPr lang="es-ES" sz="2000" b="1" dirty="0"/>
              <a:t>R</a:t>
            </a:r>
            <a:r>
              <a:rPr lang="es-ES" sz="2000" dirty="0"/>
              <a:t>.E [71, 77] DHFR</a:t>
            </a:r>
          </a:p>
        </p:txBody>
      </p:sp>
      <p:sp>
        <p:nvSpPr>
          <p:cNvPr id="18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06</a:t>
            </a:r>
            <a:r>
              <a:rPr lang="es-ES" sz="2000" dirty="0"/>
              <a:t> </a:t>
            </a:r>
          </a:p>
        </p:txBody>
      </p:sp>
      <p:sp>
        <p:nvSpPr>
          <p:cNvPr id="19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604</a:t>
            </a:r>
          </a:p>
        </p:txBody>
      </p:sp>
      <p:sp>
        <p:nvSpPr>
          <p:cNvPr id="20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7 </a:t>
            </a:r>
          </a:p>
        </p:txBody>
      </p:sp>
      <p:sp>
        <p:nvSpPr>
          <p:cNvPr id="21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22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29" name="1 Título"/>
          <p:cNvSpPr txBox="1">
            <a:spLocks/>
          </p:cNvSpPr>
          <p:nvPr/>
        </p:nvSpPr>
        <p:spPr>
          <a:xfrm>
            <a:off x="35496" y="1472228"/>
            <a:ext cx="1368152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2372" y="4716245"/>
            <a:ext cx="2103928" cy="17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2372" y="1166532"/>
            <a:ext cx="2103928" cy="17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2372" y="2970817"/>
            <a:ext cx="2103928" cy="17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1581" y="2911960"/>
            <a:ext cx="2174875" cy="18042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7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1580" y="1097244"/>
            <a:ext cx="2174875" cy="18042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8" name="Picture 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37053" y="4716245"/>
            <a:ext cx="2103928" cy="17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9" name="Picture 9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2474" y="4716245"/>
            <a:ext cx="2103929" cy="17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0" name="Picture 10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7005" y="1157767"/>
            <a:ext cx="2101920" cy="1743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Picture 11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7005" y="2901529"/>
            <a:ext cx="2139398" cy="17748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02696583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K.LTEQPELAN</a:t>
            </a:r>
            <a:r>
              <a:rPr lang="es-ES" sz="2000" b="1" dirty="0"/>
              <a:t>K</a:t>
            </a:r>
            <a:r>
              <a:rPr lang="es-ES" sz="2000" dirty="0"/>
              <a:t>.V [99, 108] DHFR</a:t>
            </a:r>
          </a:p>
        </p:txBody>
      </p:sp>
      <p:sp>
        <p:nvSpPr>
          <p:cNvPr id="18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06</a:t>
            </a:r>
            <a:r>
              <a:rPr lang="es-ES" sz="2000" dirty="0"/>
              <a:t> </a:t>
            </a:r>
          </a:p>
        </p:txBody>
      </p:sp>
      <p:sp>
        <p:nvSpPr>
          <p:cNvPr id="19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201</a:t>
            </a:r>
          </a:p>
        </p:txBody>
      </p:sp>
      <p:sp>
        <p:nvSpPr>
          <p:cNvPr id="20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50 </a:t>
            </a:r>
          </a:p>
        </p:txBody>
      </p:sp>
      <p:sp>
        <p:nvSpPr>
          <p:cNvPr id="21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22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29" name="1 Título"/>
          <p:cNvSpPr txBox="1">
            <a:spLocks/>
          </p:cNvSpPr>
          <p:nvPr/>
        </p:nvSpPr>
        <p:spPr>
          <a:xfrm>
            <a:off x="35496" y="1472228"/>
            <a:ext cx="1368152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3583" y="1157767"/>
            <a:ext cx="2101921" cy="1743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3583" y="2901529"/>
            <a:ext cx="2103929" cy="17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3582" y="4646957"/>
            <a:ext cx="2101921" cy="1743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07854" y="4646957"/>
            <a:ext cx="2118940" cy="17578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0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2464" y="1157264"/>
            <a:ext cx="2043951" cy="1695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1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2463" y="2901529"/>
            <a:ext cx="2103929" cy="17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2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2371" y="2875958"/>
            <a:ext cx="2103929" cy="17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3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2371" y="1107507"/>
            <a:ext cx="2103929" cy="174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4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2459" y="4673111"/>
            <a:ext cx="2055885" cy="17055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662299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FVIGGPQGDAGVTG</a:t>
            </a:r>
            <a:r>
              <a:rPr lang="es-ES" sz="2000" b="1" dirty="0"/>
              <a:t>R</a:t>
            </a:r>
            <a:r>
              <a:rPr lang="es-ES" sz="2000" dirty="0"/>
              <a:t>.K [249, 263]  MAT1A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2B</a:t>
            </a:r>
            <a:r>
              <a:rPr lang="es-ES" sz="2000" dirty="0"/>
              <a:t> </a:t>
            </a:r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195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6 </a:t>
            </a:r>
          </a:p>
        </p:txBody>
      </p:sp>
      <p:sp>
        <p:nvSpPr>
          <p:cNvPr id="17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18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9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8026" y="4794712"/>
            <a:ext cx="1893376" cy="17850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4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7648" y="1146707"/>
            <a:ext cx="1893376" cy="17850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5" name="Picture 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7648" y="2955755"/>
            <a:ext cx="1893376" cy="17850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6" name="Picture 8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4566" y="4794712"/>
            <a:ext cx="1859748" cy="17533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7" name="Picture 9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5040" y="2943768"/>
            <a:ext cx="1918800" cy="18090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8" name="Picture 10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4566" y="1162561"/>
            <a:ext cx="1859748" cy="17533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9" name="Picture 11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4670" y="4794713"/>
            <a:ext cx="1859749" cy="17533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80" name="Picture 12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2802" y="1196752"/>
            <a:ext cx="1823483" cy="17191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81" name="Picture 13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2803" y="2955755"/>
            <a:ext cx="1915661" cy="18060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3650583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GAVLPI</a:t>
            </a:r>
            <a:r>
              <a:rPr lang="es-ES" sz="2000" b="1" dirty="0"/>
              <a:t>R</a:t>
            </a:r>
            <a:r>
              <a:rPr lang="es-ES" sz="2000" dirty="0"/>
              <a:t>.V [192, 198] MAT2A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1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292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6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8203" name="Picture 1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59693" y="4733883"/>
            <a:ext cx="1969699" cy="18570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04" name="Picture 1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41209" y="1196752"/>
            <a:ext cx="1806666" cy="17033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05" name="Picture 1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3" y="2900078"/>
            <a:ext cx="1907251" cy="17981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06" name="Picture 1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1005" y="1196752"/>
            <a:ext cx="1806870" cy="17035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07" name="Picture 1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1005" y="2996533"/>
            <a:ext cx="1806870" cy="17035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08" name="Picture 1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1005" y="4819639"/>
            <a:ext cx="1806870" cy="17035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7202" y="1320594"/>
            <a:ext cx="1754854" cy="14558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1002" y="3057159"/>
            <a:ext cx="1907254" cy="1582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1002" y="4852195"/>
            <a:ext cx="1974924" cy="16384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59441303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FVIGGPQGDAGLTG</a:t>
            </a:r>
            <a:r>
              <a:rPr lang="es-ES" sz="2000" b="1" dirty="0"/>
              <a:t>R</a:t>
            </a:r>
            <a:r>
              <a:rPr lang="es-ES" sz="2000" dirty="0"/>
              <a:t>.K [249, 263] MAT2A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08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316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87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4915" y="4819639"/>
            <a:ext cx="1806870" cy="17035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4915" y="1187488"/>
            <a:ext cx="1806870" cy="17035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0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2665" y="2916993"/>
            <a:ext cx="1871369" cy="1764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1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4" y="1196752"/>
            <a:ext cx="1797044" cy="16942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2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4" y="2973065"/>
            <a:ext cx="1797044" cy="16942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3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90813" y="4819639"/>
            <a:ext cx="1806869" cy="17035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4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1005" y="4819640"/>
            <a:ext cx="1806870" cy="17035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5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1005" y="1187487"/>
            <a:ext cx="1806870" cy="17035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6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1005" y="2916993"/>
            <a:ext cx="1806870" cy="17035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06034475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K.AVLENNLGAAVL</a:t>
            </a:r>
            <a:r>
              <a:rPr lang="es-ES" sz="2000" b="1" dirty="0"/>
              <a:t>R</a:t>
            </a:r>
            <a:r>
              <a:rPr lang="es-ES" sz="2000" dirty="0"/>
              <a:t>.I [168, 180] [249, 263] MAT2B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3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316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87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4099" y="1058383"/>
            <a:ext cx="2192630" cy="18190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4099" y="2900269"/>
            <a:ext cx="2192630" cy="18190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4098" y="4826844"/>
            <a:ext cx="2104366" cy="17457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5242" y="1058383"/>
            <a:ext cx="2039162" cy="16916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5241" y="2900270"/>
            <a:ext cx="2192627" cy="1819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0844" y="4826844"/>
            <a:ext cx="2104365" cy="17457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8893" y="2900270"/>
            <a:ext cx="2192627" cy="1819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5012" y="1058383"/>
            <a:ext cx="2138334" cy="17739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5912" y="4826844"/>
            <a:ext cx="2104363" cy="17457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26490575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EVLIETA</a:t>
            </a:r>
            <a:r>
              <a:rPr lang="es-ES" sz="2000" b="1" dirty="0"/>
              <a:t>K</a:t>
            </a:r>
            <a:r>
              <a:rPr lang="es-ES" sz="2000" dirty="0"/>
              <a:t>.K [149, 156]  MTAP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06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317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50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00428" y="4815678"/>
            <a:ext cx="2088232" cy="1732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00428" y="1173042"/>
            <a:ext cx="2088232" cy="17324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4" y="3015436"/>
            <a:ext cx="2007840" cy="1665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9717" y="1139356"/>
            <a:ext cx="2169445" cy="17997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9716" y="2981918"/>
            <a:ext cx="2088643" cy="17327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9715" y="4815677"/>
            <a:ext cx="2088643" cy="17327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80220" y="4821718"/>
            <a:ext cx="2088232" cy="1732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655" y="1139355"/>
            <a:ext cx="2128839" cy="17660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7" name="Picture 11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654" y="2981917"/>
            <a:ext cx="2048243" cy="16992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5188061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EAYNLGV</a:t>
            </a:r>
            <a:r>
              <a:rPr lang="es-ES" sz="2000" b="1" dirty="0"/>
              <a:t>R</a:t>
            </a:r>
            <a:r>
              <a:rPr lang="es-ES" sz="2000" dirty="0"/>
              <a:t>.Y [286, 293] BHMT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1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199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7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520" y="4820913"/>
            <a:ext cx="1907354" cy="17982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520" y="1092751"/>
            <a:ext cx="1907354" cy="17982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3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90866" y="4820914"/>
            <a:ext cx="1907355" cy="17982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5" name="Picture 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90863" y="1092751"/>
            <a:ext cx="1907354" cy="17982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6" name="Picture 8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1003" y="2991753"/>
            <a:ext cx="1817008" cy="17130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7" name="Picture 9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3503" y="1152000"/>
            <a:ext cx="1781665" cy="16797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8" name="Picture 10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830" y="4820914"/>
            <a:ext cx="1907354" cy="17982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9" name="Picture 11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5692" y="2991752"/>
            <a:ext cx="1817010" cy="17130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00" name="Picture 1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6036" y="2991753"/>
            <a:ext cx="1817008" cy="17130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10918398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AIAEELAPE</a:t>
            </a:r>
            <a:r>
              <a:rPr lang="es-ES" sz="2000" b="1" dirty="0"/>
              <a:t>R</a:t>
            </a:r>
            <a:r>
              <a:rPr lang="es-ES" sz="2000" dirty="0"/>
              <a:t>.G [308, 317] BHMT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1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316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7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13320" name="Picture 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5" y="4816037"/>
            <a:ext cx="1917595" cy="18079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1" name="Picture 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4" y="2944335"/>
            <a:ext cx="1917595" cy="18079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2" name="Picture 10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1135293"/>
            <a:ext cx="1917593" cy="18079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3" name="Picture 11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5742" y="4816037"/>
            <a:ext cx="1917595" cy="18079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4" name="Picture 1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5742" y="2944338"/>
            <a:ext cx="1917595" cy="18079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5" name="Picture 1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5746" y="1083095"/>
            <a:ext cx="1917595" cy="18079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6" name="Picture 1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1813" y="2944338"/>
            <a:ext cx="1985254" cy="18716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8" name="Picture 16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8237" y="1196752"/>
            <a:ext cx="1852405" cy="17464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9" name="Picture 17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5025" y="4816037"/>
            <a:ext cx="1918829" cy="1809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112665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AIAEELAPE</a:t>
            </a:r>
            <a:r>
              <a:rPr lang="es-ES" sz="2000" b="1" dirty="0"/>
              <a:t>R</a:t>
            </a:r>
            <a:r>
              <a:rPr lang="es-ES" sz="2000" dirty="0"/>
              <a:t>.G [308, 317] BHMT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1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316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7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11" name="Picture 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5" y="4816037"/>
            <a:ext cx="1917595" cy="18079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4" y="2944335"/>
            <a:ext cx="1917595" cy="18079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10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1135293"/>
            <a:ext cx="1917593" cy="18079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11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5742" y="4816037"/>
            <a:ext cx="1917595" cy="18079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1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5742" y="2944338"/>
            <a:ext cx="1917595" cy="18079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1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5746" y="1083095"/>
            <a:ext cx="1917595" cy="18079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1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1813" y="2944338"/>
            <a:ext cx="1985254" cy="18716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16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8237" y="1196752"/>
            <a:ext cx="1852405" cy="17464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17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5025" y="4816037"/>
            <a:ext cx="1918829" cy="1809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2338548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K.AWLLGLL</a:t>
            </a:r>
            <a:r>
              <a:rPr lang="es-ES" sz="2000" b="1" dirty="0">
                <a:effectLst/>
              </a:rPr>
              <a:t>R</a:t>
            </a:r>
            <a:r>
              <a:rPr lang="es-ES" sz="2000" dirty="0"/>
              <a:t>.Q [46, 53] GNMT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389953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08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304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4 </a:t>
            </a:r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8939" y="4891900"/>
            <a:ext cx="1871002" cy="16561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8940" y="1170046"/>
            <a:ext cx="1871002" cy="1656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1" name="Picture 1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8939" y="3020201"/>
            <a:ext cx="1871001" cy="1656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2" name="Picture 1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09043" y="4891900"/>
            <a:ext cx="1871002" cy="16561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3" name="Picture 1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09044" y="1170046"/>
            <a:ext cx="1871002" cy="1656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4" name="Picture 1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09044" y="3020201"/>
            <a:ext cx="1871002" cy="1656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5" name="Picture 17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6982" y="4891900"/>
            <a:ext cx="1871002" cy="16561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6" name="Picture 18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8465" y="1170045"/>
            <a:ext cx="1871002" cy="1656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7" name="Picture 19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89951" y="2977257"/>
            <a:ext cx="1968031" cy="17420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64228912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AVLEALGS</a:t>
            </a:r>
            <a:r>
              <a:rPr lang="es-ES" sz="2000" b="1" u="sng" dirty="0"/>
              <a:t>C</a:t>
            </a:r>
            <a:r>
              <a:rPr lang="es-ES" sz="2000" dirty="0"/>
              <a:t>LNN</a:t>
            </a:r>
            <a:r>
              <a:rPr lang="es-ES" sz="2000" b="1" dirty="0"/>
              <a:t>K</a:t>
            </a:r>
            <a:r>
              <a:rPr lang="es-ES" sz="2000" dirty="0"/>
              <a:t>.Y [59, 71] SHMT1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1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292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85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3021027"/>
            <a:ext cx="1917594" cy="16545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5" y="1211981"/>
            <a:ext cx="1917595" cy="16545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4" y="4854375"/>
            <a:ext cx="2007841" cy="17323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9379" y="2982094"/>
            <a:ext cx="2007840" cy="1732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8808" y="1189812"/>
            <a:ext cx="1968981" cy="16988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85746" y="1211981"/>
            <a:ext cx="1917595" cy="16545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4" y="3001563"/>
            <a:ext cx="1962713" cy="1693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62369" y="4891900"/>
            <a:ext cx="1964350" cy="16948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1938" y="4873259"/>
            <a:ext cx="1962719" cy="16934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81394027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LGTPALTS</a:t>
            </a:r>
            <a:r>
              <a:rPr lang="es-ES" sz="2000" b="1" dirty="0"/>
              <a:t>R</a:t>
            </a:r>
            <a:r>
              <a:rPr lang="es-ES" sz="2000" dirty="0"/>
              <a:t>.G [402, 410] SHMT1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1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316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85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4854376"/>
            <a:ext cx="2007840" cy="1732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1173048"/>
            <a:ext cx="2007840" cy="1732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2982093"/>
            <a:ext cx="2007840" cy="1732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9949" y="4870558"/>
            <a:ext cx="1968981" cy="16988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9948" y="1189812"/>
            <a:ext cx="1968981" cy="16988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519" y="2990478"/>
            <a:ext cx="1988409" cy="17156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4" y="1211985"/>
            <a:ext cx="1962713" cy="1693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3" y="2990478"/>
            <a:ext cx="1962713" cy="1693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8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63188" y="4870558"/>
            <a:ext cx="1962712" cy="1693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2470626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K.TGLIDYNQLALTA</a:t>
            </a:r>
            <a:r>
              <a:rPr lang="es-ES" sz="2000" b="1" dirty="0"/>
              <a:t>R</a:t>
            </a:r>
            <a:r>
              <a:rPr lang="es-ES" sz="2000" dirty="0"/>
              <a:t>.L [200, 213] SHMT2</a:t>
            </a:r>
          </a:p>
        </p:txBody>
      </p:sp>
      <p:sp>
        <p:nvSpPr>
          <p:cNvPr id="19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1</a:t>
            </a:r>
            <a:endParaRPr lang="es-ES" sz="2000" dirty="0"/>
          </a:p>
        </p:txBody>
      </p:sp>
      <p:sp>
        <p:nvSpPr>
          <p:cNvPr id="20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316</a:t>
            </a:r>
          </a:p>
        </p:txBody>
      </p:sp>
      <p:sp>
        <p:nvSpPr>
          <p:cNvPr id="21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6 </a:t>
            </a:r>
          </a:p>
        </p:txBody>
      </p:sp>
      <p:sp>
        <p:nvSpPr>
          <p:cNvPr id="22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23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24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3" y="4893313"/>
            <a:ext cx="1962713" cy="1693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4" y="1211986"/>
            <a:ext cx="1962712" cy="1693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3" y="3001561"/>
            <a:ext cx="1962713" cy="1693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0802" y="4853793"/>
            <a:ext cx="2007841" cy="1732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0236" y="1200900"/>
            <a:ext cx="1988408" cy="1715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518" y="2998860"/>
            <a:ext cx="1988407" cy="17156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4815688"/>
            <a:ext cx="2007840" cy="1732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1173048"/>
            <a:ext cx="2007840" cy="1732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2982095"/>
            <a:ext cx="2007840" cy="1732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49122125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SAITPGGL</a:t>
            </a:r>
            <a:r>
              <a:rPr lang="es-ES" sz="2000" b="1" dirty="0"/>
              <a:t>R</a:t>
            </a:r>
            <a:r>
              <a:rPr lang="es-ES" sz="2000" dirty="0"/>
              <a:t>.L [416, 424] SHMT2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1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316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7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4853793"/>
            <a:ext cx="2007840" cy="1732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1211986"/>
            <a:ext cx="2007840" cy="1732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0416" y="2982094"/>
            <a:ext cx="2007840" cy="1732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518" y="4854374"/>
            <a:ext cx="2007842" cy="1732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520" y="2982095"/>
            <a:ext cx="2007840" cy="1732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520" y="1173048"/>
            <a:ext cx="2007840" cy="1732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3" y="4886469"/>
            <a:ext cx="1962713" cy="1693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3" y="1231454"/>
            <a:ext cx="1962713" cy="1693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3" y="3021030"/>
            <a:ext cx="1962713" cy="16934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05234015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K.AAEEVTLQTGI</a:t>
            </a:r>
            <a:r>
              <a:rPr lang="es-ES" sz="2000" b="1" dirty="0"/>
              <a:t>K</a:t>
            </a:r>
            <a:r>
              <a:rPr lang="es-ES" sz="2000" dirty="0"/>
              <a:t>.R [127, 138] METH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09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199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3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6874" y="3029090"/>
            <a:ext cx="1974924" cy="16384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6874" y="1196752"/>
            <a:ext cx="1872208" cy="15531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7982" y="4849941"/>
            <a:ext cx="2046932" cy="169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1078" y="4849941"/>
            <a:ext cx="2046931" cy="169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4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1077" y="1196750"/>
            <a:ext cx="1872207" cy="15531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5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17602" y="2871098"/>
            <a:ext cx="2027388" cy="16819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6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0974" y="4849264"/>
            <a:ext cx="2046932" cy="169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7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520" y="1196752"/>
            <a:ext cx="1940023" cy="1609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8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519" y="2871098"/>
            <a:ext cx="2027387" cy="16819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81854171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YSAPVIHVLDAS</a:t>
            </a:r>
            <a:r>
              <a:rPr lang="es-ES" sz="2000" b="1" dirty="0"/>
              <a:t>K</a:t>
            </a:r>
            <a:r>
              <a:rPr lang="es-ES" sz="2000" dirty="0"/>
              <a:t>.S [875, 887] METH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1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92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4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3928" y="4798185"/>
            <a:ext cx="2164432" cy="17956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3928" y="1185911"/>
            <a:ext cx="2057212" cy="17066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96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3928" y="2994957"/>
            <a:ext cx="2057212" cy="1706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xmlns="" id="{A856637F-CB6D-4433-AD5E-CA55E97705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51988" y="1185911"/>
            <a:ext cx="2185111" cy="1706672"/>
          </a:xfrm>
          <a:prstGeom prst="rect">
            <a:avLst/>
          </a:prstGeom>
        </p:spPr>
      </p:pic>
      <p:pic>
        <p:nvPicPr>
          <p:cNvPr id="14" name="Imagen 13">
            <a:extLst>
              <a:ext uri="{FF2B5EF4-FFF2-40B4-BE49-F238E27FC236}">
                <a16:creationId xmlns:a16="http://schemas.microsoft.com/office/drawing/2014/main" xmlns="" id="{C6C7B41B-9DD1-42A8-9655-DF1CD2F10FD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57903" y="3030626"/>
            <a:ext cx="2096476" cy="1637444"/>
          </a:xfrm>
          <a:prstGeom prst="rect">
            <a:avLst/>
          </a:prstGeom>
        </p:spPr>
      </p:pic>
      <p:pic>
        <p:nvPicPr>
          <p:cNvPr id="16" name="Imagen 15">
            <a:extLst>
              <a:ext uri="{FF2B5EF4-FFF2-40B4-BE49-F238E27FC236}">
                <a16:creationId xmlns:a16="http://schemas.microsoft.com/office/drawing/2014/main" xmlns="" id="{0DA19FB5-AC0A-4695-A24D-9E9B2A5C141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51987" y="4806113"/>
            <a:ext cx="2096477" cy="1637444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EDECADFA-DD81-4732-A487-3A95EC21682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76097" y="3030626"/>
            <a:ext cx="2096477" cy="1637444"/>
          </a:xfrm>
          <a:prstGeom prst="rect">
            <a:avLst/>
          </a:prstGeom>
        </p:spPr>
      </p:pic>
      <p:pic>
        <p:nvPicPr>
          <p:cNvPr id="20" name="Imagen 19">
            <a:extLst>
              <a:ext uri="{FF2B5EF4-FFF2-40B4-BE49-F238E27FC236}">
                <a16:creationId xmlns:a16="http://schemas.microsoft.com/office/drawing/2014/main" xmlns="" id="{58772173-73F0-4894-859D-18BBDC92CFF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48634" y="1182086"/>
            <a:ext cx="2096476" cy="1637444"/>
          </a:xfrm>
          <a:prstGeom prst="rect">
            <a:avLst/>
          </a:prstGeom>
        </p:spPr>
      </p:pic>
      <p:pic>
        <p:nvPicPr>
          <p:cNvPr id="22" name="Imagen 21">
            <a:extLst>
              <a:ext uri="{FF2B5EF4-FFF2-40B4-BE49-F238E27FC236}">
                <a16:creationId xmlns:a16="http://schemas.microsoft.com/office/drawing/2014/main" xmlns="" id="{6283F50F-4365-4E26-A016-5AFFC1D7C5D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76096" y="4956364"/>
            <a:ext cx="2096476" cy="16374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854171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LAEAFAEELHE</a:t>
            </a:r>
            <a:r>
              <a:rPr lang="es-ES" sz="2000" b="1" dirty="0"/>
              <a:t>R</a:t>
            </a:r>
            <a:r>
              <a:rPr lang="es-ES" sz="2000" dirty="0"/>
              <a:t>.V [1132, 1143] METH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36</a:t>
            </a:r>
            <a:endParaRPr lang="es-ES" sz="2000" dirty="0"/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195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7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16" name="Imagen 15">
            <a:extLst>
              <a:ext uri="{FF2B5EF4-FFF2-40B4-BE49-F238E27FC236}">
                <a16:creationId xmlns:a16="http://schemas.microsoft.com/office/drawing/2014/main" xmlns="" id="{251F4B9C-BDE9-4DFC-A560-3DAEE97A26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3928" y="2985864"/>
            <a:ext cx="2164432" cy="1690521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281DBCD8-5E24-4C8C-A94B-D638AF98FC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21924" y="1196752"/>
            <a:ext cx="2109527" cy="1647637"/>
          </a:xfrm>
          <a:prstGeom prst="rect">
            <a:avLst/>
          </a:prstGeom>
        </p:spPr>
      </p:pic>
      <p:pic>
        <p:nvPicPr>
          <p:cNvPr id="20" name="Imagen 19">
            <a:extLst>
              <a:ext uri="{FF2B5EF4-FFF2-40B4-BE49-F238E27FC236}">
                <a16:creationId xmlns:a16="http://schemas.microsoft.com/office/drawing/2014/main" xmlns="" id="{3531C3A8-1485-4DA5-9996-347DBF98DF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54941" y="4869944"/>
            <a:ext cx="2164433" cy="1690521"/>
          </a:xfrm>
          <a:prstGeom prst="rect">
            <a:avLst/>
          </a:prstGeom>
        </p:spPr>
      </p:pic>
      <p:pic>
        <p:nvPicPr>
          <p:cNvPr id="22" name="Imagen 21">
            <a:extLst>
              <a:ext uri="{FF2B5EF4-FFF2-40B4-BE49-F238E27FC236}">
                <a16:creationId xmlns:a16="http://schemas.microsoft.com/office/drawing/2014/main" xmlns="" id="{A17C4C10-3509-4111-A640-F7EEE0516F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82028" y="1157048"/>
            <a:ext cx="2109528" cy="1647638"/>
          </a:xfrm>
          <a:prstGeom prst="rect">
            <a:avLst/>
          </a:prstGeom>
        </p:spPr>
      </p:pic>
      <p:pic>
        <p:nvPicPr>
          <p:cNvPr id="24" name="Imagen 23">
            <a:extLst>
              <a:ext uri="{FF2B5EF4-FFF2-40B4-BE49-F238E27FC236}">
                <a16:creationId xmlns:a16="http://schemas.microsoft.com/office/drawing/2014/main" xmlns="" id="{AD532013-9287-42B2-924A-2CBC6F97491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62328" y="2985864"/>
            <a:ext cx="2164432" cy="1690520"/>
          </a:xfrm>
          <a:prstGeom prst="rect">
            <a:avLst/>
          </a:prstGeom>
        </p:spPr>
      </p:pic>
      <p:pic>
        <p:nvPicPr>
          <p:cNvPr id="26" name="Imagen 25">
            <a:extLst>
              <a:ext uri="{FF2B5EF4-FFF2-40B4-BE49-F238E27FC236}">
                <a16:creationId xmlns:a16="http://schemas.microsoft.com/office/drawing/2014/main" xmlns="" id="{06B1F1C1-2F39-4E64-A268-371A5395F6B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89780" y="4898748"/>
            <a:ext cx="2109527" cy="1647637"/>
          </a:xfrm>
          <a:prstGeom prst="rect">
            <a:avLst/>
          </a:prstGeom>
        </p:spPr>
      </p:pic>
      <p:pic>
        <p:nvPicPr>
          <p:cNvPr id="28" name="Imagen 27">
            <a:extLst>
              <a:ext uri="{FF2B5EF4-FFF2-40B4-BE49-F238E27FC236}">
                <a16:creationId xmlns:a16="http://schemas.microsoft.com/office/drawing/2014/main" xmlns="" id="{EB8E86DD-5516-4FD0-AE5A-42D8A2A25A4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42119" y="1157048"/>
            <a:ext cx="2164433" cy="1690521"/>
          </a:xfrm>
          <a:prstGeom prst="rect">
            <a:avLst/>
          </a:prstGeom>
        </p:spPr>
      </p:pic>
      <p:pic>
        <p:nvPicPr>
          <p:cNvPr id="30" name="Imagen 29">
            <a:extLst>
              <a:ext uri="{FF2B5EF4-FFF2-40B4-BE49-F238E27FC236}">
                <a16:creationId xmlns:a16="http://schemas.microsoft.com/office/drawing/2014/main" xmlns="" id="{273D529C-37D9-46EB-8F86-A1B8689FEA7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92190" y="2963925"/>
            <a:ext cx="2164431" cy="1690520"/>
          </a:xfrm>
          <a:prstGeom prst="rect">
            <a:avLst/>
          </a:prstGeom>
        </p:spPr>
      </p:pic>
      <p:pic>
        <p:nvPicPr>
          <p:cNvPr id="4096" name="Imagen 4095">
            <a:extLst>
              <a:ext uri="{FF2B5EF4-FFF2-40B4-BE49-F238E27FC236}">
                <a16:creationId xmlns:a16="http://schemas.microsoft.com/office/drawing/2014/main" xmlns="" id="{538DDC99-0D30-499C-91D9-603C3F7F619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20416" y="4855865"/>
            <a:ext cx="2164431" cy="1690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85417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3568" y="44624"/>
            <a:ext cx="7772400" cy="648072"/>
          </a:xfrm>
        </p:spPr>
        <p:txBody>
          <a:bodyPr>
            <a:normAutofit/>
          </a:bodyPr>
          <a:lstStyle/>
          <a:p>
            <a:r>
              <a:rPr lang="es-ES" sz="2000" dirty="0"/>
              <a:t>R.AGGLLVIDH</a:t>
            </a:r>
            <a:r>
              <a:rPr lang="es-ES" sz="2000" b="1" dirty="0">
                <a:effectLst/>
              </a:rPr>
              <a:t>R</a:t>
            </a:r>
            <a:r>
              <a:rPr lang="es-ES" sz="2000" dirty="0"/>
              <a:t>.N [168, 177] GNMT</a:t>
            </a:r>
          </a:p>
        </p:txBody>
      </p:sp>
      <p:sp>
        <p:nvSpPr>
          <p:cNvPr id="4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169</a:t>
            </a:r>
            <a:r>
              <a:rPr lang="es-ES" sz="2000" dirty="0"/>
              <a:t> 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198</a:t>
            </a:r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84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9102" y="1207981"/>
            <a:ext cx="1985460" cy="171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9101" y="2993293"/>
            <a:ext cx="1985461" cy="171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9102" y="4946572"/>
            <a:ext cx="1985460" cy="171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53" name="Picture 29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8756" y="4946572"/>
            <a:ext cx="1931366" cy="17096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54" name="Picture 30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07350" y="1207982"/>
            <a:ext cx="1931799" cy="171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55" name="Picture 31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8755" y="2993294"/>
            <a:ext cx="1931799" cy="171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56" name="Picture 32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78644" y="4864992"/>
            <a:ext cx="1931798" cy="171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57" name="Picture 33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78642" y="2993294"/>
            <a:ext cx="1931800" cy="171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58" name="Picture 34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4" y="1196751"/>
            <a:ext cx="1969818" cy="17436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6885873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K.VPAINVNDSVT</a:t>
            </a:r>
            <a:r>
              <a:rPr lang="es-ES" sz="2000" b="1" dirty="0">
                <a:effectLst/>
              </a:rPr>
              <a:t>K</a:t>
            </a:r>
            <a:r>
              <a:rPr lang="es-ES" sz="2000" dirty="0"/>
              <a:t>.S [174, 185] AHCY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73</a:t>
            </a:r>
            <a:r>
              <a:rPr lang="es-ES" sz="2000" dirty="0"/>
              <a:t> </a:t>
            </a:r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201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155 </a:t>
            </a:r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27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2332" y="1196752"/>
            <a:ext cx="1944216" cy="17289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2332" y="2983798"/>
            <a:ext cx="1944216" cy="17289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2332" y="4841352"/>
            <a:ext cx="1976028" cy="17572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95488" y="1170857"/>
            <a:ext cx="1952976" cy="1736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99868" y="2983796"/>
            <a:ext cx="1944216" cy="17289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9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4" y="4841352"/>
            <a:ext cx="2003460" cy="1781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10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6322" y="4841351"/>
            <a:ext cx="1976028" cy="17572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6410" y="1196752"/>
            <a:ext cx="1954599" cy="17382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6410" y="2976763"/>
            <a:ext cx="1954599" cy="1738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2305756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K.VAVVAGYGDVG</a:t>
            </a:r>
            <a:r>
              <a:rPr lang="es-ES" sz="2000" b="1" dirty="0">
                <a:effectLst/>
              </a:rPr>
              <a:t>K</a:t>
            </a:r>
            <a:r>
              <a:rPr lang="es-ES" sz="2000" dirty="0"/>
              <a:t>.G [214, 225] AHCY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30</a:t>
            </a:r>
            <a:r>
              <a:rPr lang="es-ES" sz="2000" dirty="0"/>
              <a:t> </a:t>
            </a:r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195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155 </a:t>
            </a:r>
          </a:p>
        </p:txBody>
      </p:sp>
      <p:sp>
        <p:nvSpPr>
          <p:cNvPr id="1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1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pic>
        <p:nvPicPr>
          <p:cNvPr id="4114" name="Picture 1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8551" y="1196752"/>
            <a:ext cx="1931778" cy="171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15" name="Picture 1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520" y="2986372"/>
            <a:ext cx="1931778" cy="171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16" name="Picture 20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8551" y="4797152"/>
            <a:ext cx="1931778" cy="171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18103" y="2996753"/>
            <a:ext cx="2052881" cy="17030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65945" y="1196752"/>
            <a:ext cx="2157198" cy="17896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624" y="4770126"/>
            <a:ext cx="2061225" cy="171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1400" y="1196752"/>
            <a:ext cx="2071534" cy="171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1400" y="2996752"/>
            <a:ext cx="2048710" cy="16996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1400" y="4699832"/>
            <a:ext cx="2071534" cy="171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94593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R.ALGAEIV</a:t>
            </a:r>
            <a:r>
              <a:rPr lang="es-ES" sz="2000" b="1" dirty="0"/>
              <a:t>R</a:t>
            </a:r>
            <a:r>
              <a:rPr lang="es-ES" sz="2000" dirty="0"/>
              <a:t>.T [182, 189] CBS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08</a:t>
            </a:r>
            <a:r>
              <a:rPr lang="es-ES" sz="2000" dirty="0"/>
              <a:t> </a:t>
            </a:r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304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7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9272" y="4815383"/>
            <a:ext cx="1918982" cy="18092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9274" y="2943684"/>
            <a:ext cx="1918982" cy="18092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9623" y="1162158"/>
            <a:ext cx="1718284" cy="16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5528" y="4891900"/>
            <a:ext cx="1837824" cy="17327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43644" y="1196752"/>
            <a:ext cx="1681591" cy="1585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5528" y="3018766"/>
            <a:ext cx="1759707" cy="16590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3" name="Picture 11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66211" y="4891901"/>
            <a:ext cx="1756664" cy="16561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4" name="Picture 12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24566" y="3018767"/>
            <a:ext cx="1839345" cy="17341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5" name="Picture 13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85401" y="1162158"/>
            <a:ext cx="1718285" cy="16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0507792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K.SNDEEAFTFA</a:t>
            </a:r>
            <a:r>
              <a:rPr lang="es-ES" sz="2000" b="1" dirty="0">
                <a:effectLst/>
              </a:rPr>
              <a:t>R</a:t>
            </a:r>
            <a:r>
              <a:rPr lang="es-ES" sz="2000" dirty="0"/>
              <a:t>.M [325, 335] CBS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36</a:t>
            </a:r>
            <a:r>
              <a:rPr lang="es-ES" sz="2000" dirty="0"/>
              <a:t> </a:t>
            </a:r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304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80 </a:t>
            </a:r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pic>
        <p:nvPicPr>
          <p:cNvPr id="5145" name="Picture 2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29481" y="4919143"/>
            <a:ext cx="1830126" cy="16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46" name="Picture 2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29481" y="3038293"/>
            <a:ext cx="1830125" cy="16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47" name="Picture 2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29482" y="1162158"/>
            <a:ext cx="1830125" cy="16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48" name="Picture 28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9273" y="4909992"/>
            <a:ext cx="1830126" cy="16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49" name="Picture 29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9273" y="1162158"/>
            <a:ext cx="1830125" cy="16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50" name="Picture 30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9272" y="3038293"/>
            <a:ext cx="1830126" cy="16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30150" y="4919144"/>
            <a:ext cx="1708577" cy="16108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30150" y="1138084"/>
            <a:ext cx="1769352" cy="16681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55683" y="3038293"/>
            <a:ext cx="1718285" cy="16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3912967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K.ISFVD</a:t>
            </a:r>
            <a:r>
              <a:rPr lang="es-ES" sz="2000" b="1" u="sng" dirty="0"/>
              <a:t>C</a:t>
            </a:r>
            <a:r>
              <a:rPr lang="es-ES" sz="2000" dirty="0"/>
              <a:t>S</a:t>
            </a:r>
            <a:r>
              <a:rPr lang="es-ES" sz="2000" b="1" dirty="0"/>
              <a:t>K</a:t>
            </a:r>
            <a:r>
              <a:rPr lang="es-ES" sz="2000" dirty="0"/>
              <a:t>.I [131, 138] CGL</a:t>
            </a:r>
          </a:p>
        </p:txBody>
      </p:sp>
      <p:sp>
        <p:nvSpPr>
          <p:cNvPr id="5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0</a:t>
            </a:r>
            <a:r>
              <a:rPr lang="es-ES" sz="2000" dirty="0"/>
              <a:t> </a:t>
            </a:r>
          </a:p>
        </p:txBody>
      </p:sp>
      <p:sp>
        <p:nvSpPr>
          <p:cNvPr id="6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199</a:t>
            </a: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94 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9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10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5229" y="4847777"/>
            <a:ext cx="1738422" cy="16389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3841" y="2996490"/>
            <a:ext cx="1806014" cy="17027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7637" y="1219754"/>
            <a:ext cx="1738422" cy="16389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98734" y="4869838"/>
            <a:ext cx="1691622" cy="1594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0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98734" y="1241815"/>
            <a:ext cx="1691622" cy="1594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1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98734" y="3050413"/>
            <a:ext cx="1691622" cy="1594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2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1249" y="4869838"/>
            <a:ext cx="1715023" cy="1616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3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1248" y="1219753"/>
            <a:ext cx="1715023" cy="1616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54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6825" y="3039382"/>
            <a:ext cx="1715022" cy="16169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077643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1 Título"/>
          <p:cNvSpPr txBox="1">
            <a:spLocks/>
          </p:cNvSpPr>
          <p:nvPr/>
        </p:nvSpPr>
        <p:spPr>
          <a:xfrm>
            <a:off x="683568" y="44624"/>
            <a:ext cx="777240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2000" dirty="0"/>
              <a:t>K.LLEAAITPET</a:t>
            </a:r>
            <a:r>
              <a:rPr lang="es-ES" sz="2000" b="1" dirty="0"/>
              <a:t>K</a:t>
            </a:r>
            <a:r>
              <a:rPr lang="es-ES" sz="2000" dirty="0"/>
              <a:t>.L [141, 151] CGL</a:t>
            </a:r>
          </a:p>
        </p:txBody>
      </p:sp>
      <p:sp>
        <p:nvSpPr>
          <p:cNvPr id="18" name="1 Título"/>
          <p:cNvSpPr txBox="1">
            <a:spLocks/>
          </p:cNvSpPr>
          <p:nvPr/>
        </p:nvSpPr>
        <p:spPr>
          <a:xfrm>
            <a:off x="1420416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Control 210</a:t>
            </a:r>
            <a:r>
              <a:rPr lang="es-ES" sz="2000" dirty="0"/>
              <a:t> </a:t>
            </a:r>
          </a:p>
        </p:txBody>
      </p:sp>
      <p:sp>
        <p:nvSpPr>
          <p:cNvPr id="19" name="1 Título"/>
          <p:cNvSpPr txBox="1">
            <a:spLocks/>
          </p:cNvSpPr>
          <p:nvPr/>
        </p:nvSpPr>
        <p:spPr>
          <a:xfrm>
            <a:off x="4080520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 err="1"/>
              <a:t>Cirrhosis</a:t>
            </a:r>
            <a:r>
              <a:rPr lang="es-ES" sz="1800" dirty="0"/>
              <a:t> 10199</a:t>
            </a:r>
          </a:p>
        </p:txBody>
      </p:sp>
      <p:sp>
        <p:nvSpPr>
          <p:cNvPr id="20" name="1 Título"/>
          <p:cNvSpPr txBox="1">
            <a:spLocks/>
          </p:cNvSpPr>
          <p:nvPr/>
        </p:nvSpPr>
        <p:spPr>
          <a:xfrm>
            <a:off x="6740624" y="548680"/>
            <a:ext cx="2007840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800" dirty="0"/>
              <a:t>Tumor 10285 </a:t>
            </a:r>
          </a:p>
        </p:txBody>
      </p:sp>
      <p:sp>
        <p:nvSpPr>
          <p:cNvPr id="21" name="1 Título"/>
          <p:cNvSpPr txBox="1">
            <a:spLocks/>
          </p:cNvSpPr>
          <p:nvPr/>
        </p:nvSpPr>
        <p:spPr>
          <a:xfrm>
            <a:off x="35496" y="3524257"/>
            <a:ext cx="1008112" cy="6480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endParaRPr lang="es-ES" sz="1600" dirty="0"/>
          </a:p>
        </p:txBody>
      </p:sp>
      <p:sp>
        <p:nvSpPr>
          <p:cNvPr id="22" name="1 Título"/>
          <p:cNvSpPr txBox="1">
            <a:spLocks/>
          </p:cNvSpPr>
          <p:nvPr/>
        </p:nvSpPr>
        <p:spPr>
          <a:xfrm>
            <a:off x="0" y="4891900"/>
            <a:ext cx="1115616" cy="16561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r>
              <a:rPr lang="es-ES" sz="1600" dirty="0"/>
              <a:t> (red) </a:t>
            </a:r>
          </a:p>
          <a:p>
            <a:r>
              <a:rPr lang="es-ES" sz="1600" dirty="0"/>
              <a:t>+</a:t>
            </a:r>
          </a:p>
          <a:p>
            <a:r>
              <a:rPr lang="es-ES" sz="1600" dirty="0"/>
              <a:t>Heavy </a:t>
            </a:r>
            <a:r>
              <a:rPr lang="es-ES" sz="1600" dirty="0" err="1"/>
              <a:t>peptide</a:t>
            </a:r>
            <a:r>
              <a:rPr lang="es-ES" sz="1600" dirty="0"/>
              <a:t> (blue)</a:t>
            </a:r>
          </a:p>
        </p:txBody>
      </p:sp>
      <p:sp>
        <p:nvSpPr>
          <p:cNvPr id="29" name="1 Título"/>
          <p:cNvSpPr txBox="1">
            <a:spLocks/>
          </p:cNvSpPr>
          <p:nvPr/>
        </p:nvSpPr>
        <p:spPr>
          <a:xfrm>
            <a:off x="72008" y="1472229"/>
            <a:ext cx="1348408" cy="1134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s-ES" sz="1600" dirty="0"/>
              <a:t>Light </a:t>
            </a:r>
            <a:r>
              <a:rPr lang="es-ES" sz="1600" dirty="0" err="1"/>
              <a:t>peptide</a:t>
            </a:r>
            <a:endParaRPr lang="es-ES" sz="1600" dirty="0"/>
          </a:p>
          <a:p>
            <a:r>
              <a:rPr lang="es-ES" sz="1600" dirty="0"/>
              <a:t>(</a:t>
            </a:r>
            <a:r>
              <a:rPr lang="es-ES" sz="1600" dirty="0" err="1"/>
              <a:t>endogenous</a:t>
            </a:r>
            <a:r>
              <a:rPr lang="es-ES" sz="1600" dirty="0"/>
              <a:t>)</a:t>
            </a:r>
          </a:p>
        </p:txBody>
      </p:sp>
      <p:pic>
        <p:nvPicPr>
          <p:cNvPr id="5131" name="Picture 1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8130" y="4818382"/>
            <a:ext cx="1912619" cy="18032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2" name="Picture 1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5739" y="1176525"/>
            <a:ext cx="1817400" cy="17134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3" name="Picture 1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8129" y="2946683"/>
            <a:ext cx="1912619" cy="18032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4" name="Picture 1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53508" y="4752900"/>
            <a:ext cx="1982074" cy="18687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5" name="Picture 1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53508" y="1104896"/>
            <a:ext cx="1982074" cy="18687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6" name="Picture 1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53508" y="2913942"/>
            <a:ext cx="1982074" cy="18687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8" name="Picture 1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8026" y="4818382"/>
            <a:ext cx="1912620" cy="18032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39" name="Picture 1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8026" y="1104896"/>
            <a:ext cx="1893376" cy="17850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40" name="Picture 2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8026" y="2955753"/>
            <a:ext cx="1893376" cy="17850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7624174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01</TotalTime>
  <Words>870</Words>
  <Application>Microsoft Office PowerPoint</Application>
  <PresentationFormat>Presentación en pantalla (4:3)</PresentationFormat>
  <Paragraphs>252</Paragraphs>
  <Slides>26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6</vt:i4>
      </vt:variant>
    </vt:vector>
  </HeadingPairs>
  <TitlesOfParts>
    <vt:vector size="27" baseType="lpstr">
      <vt:lpstr>Tema de Office</vt:lpstr>
      <vt:lpstr>Presentación de PowerPoint</vt:lpstr>
      <vt:lpstr>Presentación de PowerPoint</vt:lpstr>
      <vt:lpstr>R.AGGLLVIDHR.N [168, 177] GNM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.VWQLYIGDTR.S [29, 38] GNMT</dc:title>
  <dc:creator>gema</dc:creator>
  <cp:lastModifiedBy>Laura </cp:lastModifiedBy>
  <cp:revision>72</cp:revision>
  <dcterms:created xsi:type="dcterms:W3CDTF">2021-03-08T15:28:23Z</dcterms:created>
  <dcterms:modified xsi:type="dcterms:W3CDTF">2021-06-16T09:22:03Z</dcterms:modified>
</cp:coreProperties>
</file>